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81" d="100"/>
          <a:sy n="81" d="100"/>
        </p:scale>
        <p:origin x="309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4E8E8-8F0B-40F6-ABC6-6A0668F125A0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97E28-E1FF-4A44-9104-55BFC2D0F535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4770269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4E8E8-8F0B-40F6-ABC6-6A0668F125A0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97E28-E1FF-4A44-9104-55BFC2D0F535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8274414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4E8E8-8F0B-40F6-ABC6-6A0668F125A0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97E28-E1FF-4A44-9104-55BFC2D0F535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41260369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4E8E8-8F0B-40F6-ABC6-6A0668F125A0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97E28-E1FF-4A44-9104-55BFC2D0F535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2393883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4E8E8-8F0B-40F6-ABC6-6A0668F125A0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97E28-E1FF-4A44-9104-55BFC2D0F535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068019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4E8E8-8F0B-40F6-ABC6-6A0668F125A0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97E28-E1FF-4A44-9104-55BFC2D0F535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42207563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4E8E8-8F0B-40F6-ABC6-6A0668F125A0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97E28-E1FF-4A44-9104-55BFC2D0F535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40853470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4E8E8-8F0B-40F6-ABC6-6A0668F125A0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97E28-E1FF-4A44-9104-55BFC2D0F535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8482285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4E8E8-8F0B-40F6-ABC6-6A0668F125A0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97E28-E1FF-4A44-9104-55BFC2D0F535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4629282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4E8E8-8F0B-40F6-ABC6-6A0668F125A0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97E28-E1FF-4A44-9104-55BFC2D0F535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281029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4E8E8-8F0B-40F6-ABC6-6A0668F125A0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97E28-E1FF-4A44-9104-55BFC2D0F535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0550824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44E8E8-8F0B-40F6-ABC6-6A0668F125A0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B97E28-E1FF-4A44-9104-55BFC2D0F535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2382676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74401965"/>
              </p:ext>
            </p:extLst>
          </p:nvPr>
        </p:nvGraphicFramePr>
        <p:xfrm>
          <a:off x="130214" y="216655"/>
          <a:ext cx="4948594" cy="3659505"/>
        </p:xfrm>
        <a:graphic>
          <a:graphicData uri="http://schemas.openxmlformats.org/drawingml/2006/table">
            <a:tbl>
              <a:tblPr/>
              <a:tblGrid>
                <a:gridCol w="142689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52169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IE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able S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11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imeTime</a:t>
                      </a:r>
                      <a:r>
                        <a:rPr lang="en-IE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® qPCR assays used in this study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IE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croRN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ssay ID (Thermo Fisher Scientific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b"/>
                      <a:r>
                        <a:rPr lang="en-IE" sz="11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M:001973 (housekeeper gene)</a:t>
                      </a:r>
                      <a:endParaRPr lang="en-I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b"/>
                      <a:r>
                        <a:rPr lang="en-IE" sz="11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as-miR-219-2-3p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M:00239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b"/>
                      <a:r>
                        <a:rPr lang="en-IE" sz="11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as-miR-20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M:00051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IE" sz="11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mu-miR-187*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1200" b="0" i="0" u="none" strike="noStrike">
                          <a:solidFill>
                            <a:srgbClr val="333333"/>
                          </a:solidFill>
                          <a:effectLst/>
                          <a:latin typeface="Helvetica Neue"/>
                        </a:rPr>
                        <a:t>TM:463815_ma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b"/>
                      <a:r>
                        <a:rPr lang="en-IE" sz="11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mu-miR-67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M:00195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b"/>
                      <a:r>
                        <a:rPr lang="en-IE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mu-miR-18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M:00259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b"/>
                      <a:r>
                        <a:rPr lang="en-IE" sz="11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mu-miR-362-3p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M:00261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b"/>
                      <a:r>
                        <a:rPr lang="en-IE" sz="11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mu-miR-353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M:CSWRIWR (custom primer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b"/>
                      <a:r>
                        <a:rPr lang="en-IE" sz="11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as-miR-12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M:00224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b"/>
                      <a:r>
                        <a:rPr lang="en-IE" sz="11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no-miR-67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M:00205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b"/>
                      <a:r>
                        <a:rPr lang="en-IE" sz="11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mu-miR-196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M:121138_ma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b"/>
                      <a:r>
                        <a:rPr lang="en-IE" sz="11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as-miR-18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M:00226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b"/>
                      <a:r>
                        <a:rPr lang="en-IE" sz="11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mu-miR-18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M:00119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b"/>
                      <a:r>
                        <a:rPr lang="en-IE" sz="11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mu-miR-13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M:00112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b"/>
                      <a:r>
                        <a:rPr lang="en-IE" sz="11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mu-miR-512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M:465019_ma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b"/>
                      <a:r>
                        <a:rPr lang="en-IE" sz="11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as-miR-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M:00222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b"/>
                      <a:r>
                        <a:rPr lang="en-IE" sz="11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as-miR-369-3p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M:00055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90500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IE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ll</a:t>
                      </a:r>
                      <a:r>
                        <a:rPr lang="en-IE" sz="11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</a:t>
                      </a:r>
                      <a:r>
                        <a:rPr lang="en-IE" sz="1100" b="1" i="1" u="sng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as</a:t>
                      </a:r>
                      <a:r>
                        <a:rPr lang="en-IE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labelled probes detects mouse, rat and human miRN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I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127845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72</Words>
  <Application>Microsoft Office PowerPoint</Application>
  <PresentationFormat>A4 Paper (210x297 mm)</PresentationFormat>
  <Paragraphs>3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 Neue</vt:lpstr>
      <vt:lpstr>Office Theme</vt:lpstr>
      <vt:lpstr>PowerPoint Presentation</vt:lpstr>
    </vt:vector>
  </TitlesOfParts>
  <Company>Hewlett-Packar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an</dc:creator>
  <cp:lastModifiedBy>Hoban, Alan</cp:lastModifiedBy>
  <cp:revision>2</cp:revision>
  <dcterms:created xsi:type="dcterms:W3CDTF">2016-09-14T12:45:58Z</dcterms:created>
  <dcterms:modified xsi:type="dcterms:W3CDTF">2017-01-14T12:56:43Z</dcterms:modified>
</cp:coreProperties>
</file>